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  <p:sldId id="260" r:id="rId6"/>
  </p:sldIdLst>
  <p:sldSz cx="6858000" cy="109728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86" d="100"/>
          <a:sy n="86" d="100"/>
        </p:scale>
        <p:origin x="1470" y="-3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795781"/>
            <a:ext cx="5829300" cy="382016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763261"/>
            <a:ext cx="5143500" cy="2649219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79E66-0590-46FF-A527-B87816E6183E}" type="datetimeFigureOut">
              <a:rPr lang="en-US" smtClean="0"/>
              <a:t>02-Dec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A54CCE-92A0-4EF5-B42D-A49E557C88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25509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79E66-0590-46FF-A527-B87816E6183E}" type="datetimeFigureOut">
              <a:rPr lang="en-US" smtClean="0"/>
              <a:t>02-Dec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A54CCE-92A0-4EF5-B42D-A49E557C88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28831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84200"/>
            <a:ext cx="1478756" cy="9298941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84200"/>
            <a:ext cx="4350544" cy="9298941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79E66-0590-46FF-A527-B87816E6183E}" type="datetimeFigureOut">
              <a:rPr lang="en-US" smtClean="0"/>
              <a:t>02-Dec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A54CCE-92A0-4EF5-B42D-A49E557C88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70269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79E66-0590-46FF-A527-B87816E6183E}" type="datetimeFigureOut">
              <a:rPr lang="en-US" smtClean="0"/>
              <a:t>02-Dec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A54CCE-92A0-4EF5-B42D-A49E557C88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29152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735583"/>
            <a:ext cx="5915025" cy="456437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7343143"/>
            <a:ext cx="5915025" cy="24002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79E66-0590-46FF-A527-B87816E6183E}" type="datetimeFigureOut">
              <a:rPr lang="en-US" smtClean="0"/>
              <a:t>02-Dec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A54CCE-92A0-4EF5-B42D-A49E557C88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77465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921000"/>
            <a:ext cx="2914650" cy="6962141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921000"/>
            <a:ext cx="2914650" cy="6962141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79E66-0590-46FF-A527-B87816E6183E}" type="datetimeFigureOut">
              <a:rPr lang="en-US" smtClean="0"/>
              <a:t>02-Dec-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A54CCE-92A0-4EF5-B42D-A49E557C88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23003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84202"/>
            <a:ext cx="5915025" cy="2120901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689861"/>
            <a:ext cx="2901255" cy="131825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008120"/>
            <a:ext cx="2901255" cy="5895341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689861"/>
            <a:ext cx="2915543" cy="131825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008120"/>
            <a:ext cx="2915543" cy="5895341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79E66-0590-46FF-A527-B87816E6183E}" type="datetimeFigureOut">
              <a:rPr lang="en-US" smtClean="0"/>
              <a:t>02-Dec-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A54CCE-92A0-4EF5-B42D-A49E557C88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76946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79E66-0590-46FF-A527-B87816E6183E}" type="datetimeFigureOut">
              <a:rPr lang="en-US" smtClean="0"/>
              <a:t>02-Dec-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A54CCE-92A0-4EF5-B42D-A49E557C88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765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79E66-0590-46FF-A527-B87816E6183E}" type="datetimeFigureOut">
              <a:rPr lang="en-US" smtClean="0"/>
              <a:t>02-Dec-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A54CCE-92A0-4EF5-B42D-A49E557C88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10144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731520"/>
            <a:ext cx="2211884" cy="256032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579882"/>
            <a:ext cx="3471863" cy="7797800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291840"/>
            <a:ext cx="2211884" cy="6098541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79E66-0590-46FF-A527-B87816E6183E}" type="datetimeFigureOut">
              <a:rPr lang="en-US" smtClean="0"/>
              <a:t>02-Dec-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A54CCE-92A0-4EF5-B42D-A49E557C88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5941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731520"/>
            <a:ext cx="2211884" cy="256032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579882"/>
            <a:ext cx="3471863" cy="7797800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291840"/>
            <a:ext cx="2211884" cy="6098541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79E66-0590-46FF-A527-B87816E6183E}" type="datetimeFigureOut">
              <a:rPr lang="en-US" smtClean="0"/>
              <a:t>02-Dec-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A54CCE-92A0-4EF5-B42D-A49E557C88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97330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84202"/>
            <a:ext cx="5915025" cy="212090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921000"/>
            <a:ext cx="5915025" cy="696214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0170162"/>
            <a:ext cx="1543050" cy="5842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079E66-0590-46FF-A527-B87816E6183E}" type="datetimeFigureOut">
              <a:rPr lang="en-US" smtClean="0"/>
              <a:t>02-Dec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0170162"/>
            <a:ext cx="2314575" cy="5842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0170162"/>
            <a:ext cx="1543050" cy="5842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A54CCE-92A0-4EF5-B42D-A49E557C88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57806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0" y="9205192"/>
            <a:ext cx="378904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</a:t>
            </a: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 (1</a:t>
            </a: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high density consensus linkage map of mandarin. On the map, </a:t>
            </a:r>
            <a:r>
              <a:rPr lang="en-US" sz="1200" i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d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200" i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lue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 </a:t>
            </a:r>
            <a:r>
              <a:rPr lang="en-US" sz="1200" i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ark grey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olored markers are specific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o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B8-9 Sugar Belle</a:t>
            </a:r>
            <a:r>
              <a:rPr lang="en-US" sz="1200" baseline="30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®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‘SB’), Daisy (‘D’) and Mukaku Kishu (‘MK’), respectively. The </a:t>
            </a:r>
            <a:r>
              <a:rPr lang="en-US" sz="1200" i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live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olored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arkers are common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o both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‘SB’ and ‘D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’.</a:t>
            </a:r>
            <a:endParaRPr lang="en-US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" r="-450" b="2084"/>
          <a:stretch/>
        </p:blipFill>
        <p:spPr>
          <a:xfrm>
            <a:off x="142647" y="228600"/>
            <a:ext cx="6632385" cy="10744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163193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-1438" b="23512"/>
          <a:stretch/>
        </p:blipFill>
        <p:spPr>
          <a:xfrm>
            <a:off x="127644" y="522512"/>
            <a:ext cx="6697699" cy="839288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0" y="8714184"/>
            <a:ext cx="68580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</a:t>
            </a: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(2</a:t>
            </a: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high density consensus linkage map of mandarin. On the map,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d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lue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US" sz="1200" i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ark grey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lored markers are specific to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‘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B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’, ‘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’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‘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K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’,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spectively. The </a:t>
            </a:r>
            <a:r>
              <a:rPr lang="en-US" sz="1200" i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live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olored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arkers are common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o both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‘SB’ and ‘D’ while </a:t>
            </a:r>
            <a:r>
              <a:rPr lang="en-US" sz="1200" i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yan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olored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arkers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present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markers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at showed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ranslocation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rom other chromosomes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respect to their actual location on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Clementine reference genome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n-US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964930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111211" y="855413"/>
            <a:ext cx="6616056" cy="9727376"/>
            <a:chOff x="111211" y="855413"/>
            <a:chExt cx="6616056" cy="9727376"/>
          </a:xfrm>
        </p:grpSpPr>
        <p:sp>
          <p:nvSpPr>
            <p:cNvPr id="3" name="TextBox 2"/>
            <p:cNvSpPr txBox="1"/>
            <p:nvPr/>
          </p:nvSpPr>
          <p:spPr>
            <a:xfrm>
              <a:off x="111211" y="9551738"/>
              <a:ext cx="6553200" cy="10310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>
                <a:spcAft>
                  <a:spcPts val="800"/>
                </a:spcAft>
              </a:pPr>
              <a:r>
                <a:rPr lang="en-US" sz="1200" b="1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Supplementary Figure</a:t>
              </a:r>
              <a:r>
                <a:rPr lang="en-US" sz="1200" b="1" dirty="0" smtClean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sz="1200" b="1" dirty="0" smtClean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1(3</a:t>
              </a:r>
              <a:r>
                <a:rPr lang="en-US" sz="1200" b="1" dirty="0" smtClean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).</a:t>
              </a:r>
              <a:r>
                <a:rPr lang="en-US" sz="1200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The high density consensus linkage map of mandarin. On the map, </a:t>
              </a:r>
              <a:r>
                <a:rPr lang="en-US" sz="1200" i="1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red</a:t>
              </a:r>
              <a:r>
                <a:rPr lang="en-US" sz="1200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, </a:t>
              </a:r>
              <a:r>
                <a:rPr lang="en-US" sz="1200" i="1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blue</a:t>
              </a:r>
              <a:r>
                <a:rPr lang="en-US" sz="1200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and </a:t>
              </a:r>
              <a:r>
                <a:rPr lang="en-US" sz="1200" i="1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dark grey</a:t>
              </a:r>
              <a:r>
                <a:rPr lang="en-US" sz="1200" dirty="0" smtClean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sz="1200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colored markers are specific to ‘SB’, ‘D’ and ‘MK’, respectively. The </a:t>
              </a:r>
              <a:r>
                <a:rPr lang="en-US" sz="1200" i="1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olive</a:t>
              </a:r>
              <a:r>
                <a:rPr lang="en-US" sz="1200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colored markers are common to both ‘SB’ and ‘D’ while </a:t>
              </a:r>
              <a:r>
                <a:rPr lang="en-US" sz="1200" i="1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cyan</a:t>
              </a:r>
              <a:r>
                <a:rPr lang="en-US" sz="1200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colored markers represent the markers that showed translocation from other chromosomes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with respect to their actual location on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e Clementine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ference genome</a:t>
              </a:r>
              <a:r>
                <a:rPr lang="en-US" sz="1200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..</a:t>
              </a:r>
            </a:p>
          </p:txBody>
        </p:sp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-202" b="20747"/>
            <a:stretch/>
          </p:blipFill>
          <p:spPr>
            <a:xfrm>
              <a:off x="111211" y="855413"/>
              <a:ext cx="6616056" cy="8696325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76249976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933" t="-321" r="3392" b="28525"/>
          <a:stretch/>
        </p:blipFill>
        <p:spPr>
          <a:xfrm>
            <a:off x="164121" y="1172505"/>
            <a:ext cx="6506309" cy="7877907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17230" y="9375892"/>
            <a:ext cx="65532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</a:t>
            </a: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(4</a:t>
            </a: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high density consensus linkage map of mandarin. On the map,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d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lue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ark grey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lored markers are specific to ‘SB’, ‘D’ and ‘MK’, respectively. The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live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olored markers are common to both ‘SB’ and ‘D’ while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yan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olored markers represent the markers that showed translocation from other chromosome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ith respect to their actual location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 the Clementin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ference genome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n-US" sz="1200" dirty="0" smtClean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0858244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356" t="-695" r="-203" b="12153"/>
          <a:stretch/>
        </p:blipFill>
        <p:spPr>
          <a:xfrm>
            <a:off x="152400" y="304800"/>
            <a:ext cx="6705600" cy="97155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52400" y="9666177"/>
            <a:ext cx="65532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</a:t>
            </a:r>
            <a:r>
              <a:rPr lang="en-US" sz="1200" b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</a:t>
            </a:r>
            <a:r>
              <a:rPr lang="en-US" sz="1200" b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b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(5</a:t>
            </a: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high density consensus linkage map of mandarin. On the map,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d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lue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ark grey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lored markers are specific to ‘SB’, ‘D’ and ‘MK’, respectively. The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live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olored markers are common to both ‘SB’ and ‘D’ while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yan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olored markers represent the markers that showed translocation from other chromosome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ith respect to their actual location on the Clementine reference genome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n-US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093907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9</TotalTime>
  <Words>384</Words>
  <Application>Microsoft Office PowerPoint</Application>
  <PresentationFormat>Custom</PresentationFormat>
  <Paragraphs>5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account</dc:creator>
  <cp:lastModifiedBy>Microsoft account</cp:lastModifiedBy>
  <cp:revision>30</cp:revision>
  <dcterms:created xsi:type="dcterms:W3CDTF">2022-10-14T07:40:35Z</dcterms:created>
  <dcterms:modified xsi:type="dcterms:W3CDTF">2022-12-02T17:05:50Z</dcterms:modified>
</cp:coreProperties>
</file>